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1426" y="5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9981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0903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3370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9832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58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031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1055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1260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373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5945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834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2E673-1593-4064-A42E-9CEF47EA1BD1}" type="datetimeFigureOut">
              <a:rPr lang="en-GB" smtClean="0"/>
              <a:t>30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46B19-B75C-48E2-90F1-0D19CD68C3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6810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0530748"/>
              </p:ext>
            </p:extLst>
          </p:nvPr>
        </p:nvGraphicFramePr>
        <p:xfrm>
          <a:off x="1043608" y="2276872"/>
          <a:ext cx="6946899" cy="1621532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788248"/>
                <a:gridCol w="1740144"/>
                <a:gridCol w="1368152"/>
                <a:gridCol w="576002"/>
                <a:gridCol w="447062"/>
                <a:gridCol w="1027291"/>
              </a:tblGrid>
              <a:tr h="28803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Sample I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Cell type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Disease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Mutation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Sex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Age at biopsy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6311-I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Immortalised myoblast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MD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el 45-5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8036-I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mmortalised myoblast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MD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el 48-5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803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n immortalised Myoblast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 smtClean="0">
                          <a:effectLst/>
                        </a:rPr>
                        <a:t>DMD</a:t>
                      </a:r>
                      <a:endParaRPr lang="en-GB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el 48-5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M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H10-637A-I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mmortalised myoblast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DMD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del 44-5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7304-I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mmortalised myoblast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ontrol - scoliosi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F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220-I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mmortalised myoblast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ontrol - cerebral pals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F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KM155C25Dis (L954/1284M-I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mmortalised myoblast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normal control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M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5508104" y="476672"/>
            <a:ext cx="27026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Dibenedetto</a:t>
            </a:r>
            <a:r>
              <a:rPr lang="en-GB" dirty="0" smtClean="0"/>
              <a:t> et al. Table S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89848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10"/>
  <p:tag name="MMPROD_UIDATA" val="&lt;database version=&quot;7.0&quot;&gt;&lt;object type=&quot;1&quot; unique_id=&quot;10001&quot;&gt;&lt;object type=&quot;8&quot; unique_id=&quot;10150&quot;&gt;&lt;/object&gt;&lt;object type=&quot;2&quot; unique_id=&quot;10151&quot;&gt;&lt;object type=&quot;3&quot; unique_id=&quot;10152&quot;&gt;&lt;property id=&quot;20148&quot; value=&quot;5&quot;/&gt;&lt;property id=&quot;20300&quot; value=&quot;Slide 1&quot;/&gt;&lt;property id=&quot;20307&quot; value=&quot;256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6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dibenedetto</dc:creator>
  <cp:lastModifiedBy>Florent Campo-Paysaa</cp:lastModifiedBy>
  <cp:revision>4</cp:revision>
  <dcterms:created xsi:type="dcterms:W3CDTF">2016-06-23T16:59:39Z</dcterms:created>
  <dcterms:modified xsi:type="dcterms:W3CDTF">2017-06-30T15:24:24Z</dcterms:modified>
</cp:coreProperties>
</file>